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1" r:id="rId3"/>
    <p:sldId id="27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6F9374-A9D8-4071-9B2C-F894140CD5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B51D99-C1C8-4DD1-8D24-69580DB27B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76F5FB-8B45-42E6-A15A-302DB6939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3A06C1-1963-4A0C-858F-9853B6654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6B0A5A-0193-4139-BE15-7D303621D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244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28ACF-9043-4DEE-BD11-F7A16DC4EB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161436-71E9-422F-BA8B-1502B4C57A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FEDD47-621A-471A-A573-2FB5B45F4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3BA176-15E2-4AC2-99F4-60C97F389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32D2DB-272D-47F6-BCC3-42B1BED7E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DF40F5-A598-4DCC-9CD4-DB4420B886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97E930-13D9-4B1D-8A28-173A2A3F0C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AF2F9E-481F-467F-92AA-39FF3E8A6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9F7D4C-1CAA-43E7-B457-A896A8336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DA2CD0-71BC-4132-91FF-614DDD3DA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6938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5B5493-B803-420C-BBCF-EEE422B9CD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B0C5C1-BA47-47F0-9988-D5153C5BD2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8030C-07EF-4A59-8B94-DAC491BD6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92622C-1CF8-4841-93B9-4E8539B40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C9D03-7EA1-47CE-A52C-64D3E5818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9188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36D6C0-6083-4E03-92E0-2850B7C118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A20F09-9322-4412-9120-13DACA5163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5C5B1F-6DC1-4478-A960-EE88E3625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1DA797-946E-4BF8-99C5-DB630EFCA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8B7570-F330-4E7B-B2A3-1BF5C81A7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2471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0DC4E4-0FDD-4B93-99D5-DEA9E50DB3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F5509D-0F7A-40A3-B180-427BF96EC1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282014-D0A9-4EAB-8BF7-93490F8478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853A05-814A-49C9-B263-D734F0C50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AB1A23-4950-43EF-938F-DCBF67EA6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29E93D-36D5-460D-BCEF-FE92A69B1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804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322C9E-F261-4732-B052-D975C9918C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7C506D-203C-4E64-9295-CAC1AE1CAA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F94AE4-36DF-48E3-913F-D145CFA2AB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B94A25-8F6E-46EC-9C2E-96CF83700E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25856C3-E0A5-4751-A35E-6B1783897C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471A60E-0592-47FE-B772-7B37CD7DC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1EEB54-DC50-45F7-BBDF-B37D99693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2EA3CD-C901-49AB-BB76-CD7A93A5E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8936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7F31F-AF39-4DA4-82EE-4DE885916E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A31078-885A-4E63-B4BE-FAD78A00B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2FEC42-5C8B-42A4-945E-E2DE02E90F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C2AF39-5CB6-45D0-ADF4-353653140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670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DF21C0E-8DE7-440A-975B-CE16A2835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78D519-B5A3-42C5-9BEC-04A29025A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6DF504-49CE-4576-92B0-20C999F1C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643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FDC5B-D44F-49AA-A71D-382783FBB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FE3712-2F27-4454-84ED-5FE49190A0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07BD44-C1BD-4272-8A28-0D7840B63D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827811-8922-4635-95E6-2AF9CB6B6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29ED8C-937F-48C2-8AF9-B31BFFEE6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B0CFDC-086C-4C3C-8343-DEBB9CFAA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8342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32D85-D55D-4447-970B-29DE9DECA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A83402-24FA-4900-80D0-024306F1A0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F57C21-4500-4784-9BAD-4C301DE306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AD7F3A-289D-4606-A9FA-CF4BF68BF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0CD4B0-587B-46C7-9A88-66701B6C5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FDF173-F9C1-4A56-AE70-D7AF9E68D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8519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22FD51-904E-4E47-BAE0-FAE5F4BE75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8112B8-B902-4A15-8065-043FC8E0F4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A9D98-70EC-49E7-99B9-F4552672B4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8EF768-AE81-4C57-A2A0-C2283228E831}" type="datetimeFigureOut">
              <a:rPr lang="en-GB" smtClean="0"/>
              <a:t>09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9B6CD9-483A-4F8D-9D2E-AE84130A7D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2E0B2E-E8A4-4D2E-8A89-4E7320628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4A9D16-A0C3-420E-83B9-4CAC24386A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5110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1469" b="-2"/>
          <a:stretch/>
        </p:blipFill>
        <p:spPr>
          <a:xfrm>
            <a:off x="2530264" y="1052738"/>
            <a:ext cx="7370516" cy="302433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063553" y="2154343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5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991545" y="809728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kD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639617" y="809728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431705" y="807399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439817" y="809728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951985" y="803378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215681" y="476318"/>
            <a:ext cx="182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cs typeface="Arial" pitchFamily="34" charset="0"/>
              </a:rPr>
              <a:t>His-</a:t>
            </a:r>
            <a:r>
              <a:rPr lang="en-GB" sz="1600" dirty="0" err="1">
                <a:cs typeface="Arial" pitchFamily="34" charset="0"/>
              </a:rPr>
              <a:t>NlpI</a:t>
            </a:r>
            <a:r>
              <a:rPr lang="en-GB" sz="1600" dirty="0">
                <a:cs typeface="Arial" pitchFamily="34" charset="0"/>
              </a:rPr>
              <a:t> + PBP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063553" y="2636913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43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063553" y="3140969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34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063553" y="3738519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26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3215681" y="814872"/>
            <a:ext cx="181756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5591945" y="814872"/>
            <a:ext cx="181756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744073" y="814872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567562" y="469346"/>
            <a:ext cx="182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cs typeface="Arial" pitchFamily="34" charset="0"/>
              </a:rPr>
              <a:t>His-</a:t>
            </a:r>
            <a:r>
              <a:rPr lang="en-GB" sz="1600" dirty="0" err="1">
                <a:cs typeface="Arial" pitchFamily="34" charset="0"/>
              </a:rPr>
              <a:t>NlpI</a:t>
            </a:r>
            <a:r>
              <a:rPr lang="en-GB" sz="1600" dirty="0">
                <a:cs typeface="Arial" pitchFamily="34" charset="0"/>
              </a:rPr>
              <a:t>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146950" y="795836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A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7786910" y="807330"/>
            <a:ext cx="181756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8939038" y="807330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762527" y="461804"/>
            <a:ext cx="182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cs typeface="Arial" pitchFamily="34" charset="0"/>
              </a:rPr>
              <a:t>PBP4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309004" y="80103"/>
            <a:ext cx="35739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n vitro cross-linking – His-NlpI-PBP4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271465" y="2339589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BP4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055441" y="327569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is-</a:t>
            </a:r>
            <a:r>
              <a:rPr lang="en-GB" dirty="0" err="1"/>
              <a:t>NlpI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54160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2530263" y="2210380"/>
            <a:ext cx="7370516" cy="14346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/>
          <p:cNvSpPr txBox="1"/>
          <p:nvPr/>
        </p:nvSpPr>
        <p:spPr>
          <a:xfrm>
            <a:off x="2135560" y="2147525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5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063552" y="1854349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kD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639616" y="1861166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M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31704" y="1858837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439817" y="1861166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951984" y="1854816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215681" y="1527756"/>
            <a:ext cx="182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cs typeface="Arial" pitchFamily="34" charset="0"/>
              </a:rPr>
              <a:t>His-</a:t>
            </a:r>
            <a:r>
              <a:rPr lang="en-GB" sz="1600" dirty="0" err="1">
                <a:cs typeface="Arial" pitchFamily="34" charset="0"/>
              </a:rPr>
              <a:t>NlpI</a:t>
            </a:r>
            <a:r>
              <a:rPr lang="en-GB" sz="1600" dirty="0">
                <a:cs typeface="Arial" pitchFamily="34" charset="0"/>
              </a:rPr>
              <a:t> + PBP4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135560" y="2492896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43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135560" y="2874422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3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135560" y="3378478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26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3215681" y="1866310"/>
            <a:ext cx="181756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591945" y="1866310"/>
            <a:ext cx="181756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6744073" y="1866310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567562" y="1520784"/>
            <a:ext cx="182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cs typeface="Arial" pitchFamily="34" charset="0"/>
              </a:rPr>
              <a:t>His-</a:t>
            </a:r>
            <a:r>
              <a:rPr lang="en-GB" sz="1600" dirty="0" err="1">
                <a:cs typeface="Arial" pitchFamily="34" charset="0"/>
              </a:rPr>
              <a:t>NlpI</a:t>
            </a:r>
            <a:r>
              <a:rPr lang="en-GB" sz="1600" dirty="0">
                <a:cs typeface="Arial" pitchFamily="34" charset="0"/>
              </a:rPr>
              <a:t>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146949" y="1847274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A</a:t>
            </a:r>
          </a:p>
        </p:txBody>
      </p:sp>
      <p:cxnSp>
        <p:nvCxnSpPr>
          <p:cNvPr id="25" name="Straight Connector 24"/>
          <p:cNvCxnSpPr/>
          <p:nvPr/>
        </p:nvCxnSpPr>
        <p:spPr>
          <a:xfrm>
            <a:off x="7786910" y="1858768"/>
            <a:ext cx="181756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8939038" y="1858768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cs typeface="Arial" pitchFamily="34" charset="0"/>
              </a:rPr>
              <a:t>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762527" y="1513242"/>
            <a:ext cx="182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cs typeface="Arial" pitchFamily="34" charset="0"/>
              </a:rPr>
              <a:t>PBP4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367808" y="992922"/>
            <a:ext cx="35739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In vitro </a:t>
            </a:r>
            <a:r>
              <a:rPr lang="en-GB" dirty="0"/>
              <a:t>cross-linking – His-NlpI-PBP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59496" y="2348880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BP4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71464" y="306896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is-</a:t>
            </a:r>
            <a:r>
              <a:rPr lang="en-GB" dirty="0" err="1"/>
              <a:t>NlpI</a:t>
            </a:r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9292" y="2239407"/>
            <a:ext cx="7341487" cy="13985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786410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4151784" y="404664"/>
            <a:ext cx="35739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In vitro </a:t>
            </a:r>
            <a:r>
              <a:rPr lang="en-GB" dirty="0"/>
              <a:t>cross-linking – His-NlpI-PBP4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500" y="2338956"/>
            <a:ext cx="5349347" cy="23141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3044206" y="3140968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972198" y="1998365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529212" y="2005182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21768" y="2002853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772399" y="2005182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345904" y="1998832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044206" y="3450486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044206" y="3810526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044206" y="4314582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4034955" y="2010326"/>
            <a:ext cx="10016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887244" y="2010326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839074" y="1431827"/>
            <a:ext cx="18245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is-NlpI</a:t>
            </a:r>
          </a:p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PBP4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044206" y="2852936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044206" y="2586390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938290" y="2367930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938860" y="2214388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079952" y="1196753"/>
            <a:ext cx="9701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is-NlpI </a:t>
            </a:r>
          </a:p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LpoA</a:t>
            </a:r>
          </a:p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PBP4</a:t>
            </a:r>
          </a:p>
        </p:txBody>
      </p:sp>
      <p:cxnSp>
        <p:nvCxnSpPr>
          <p:cNvPr id="32" name="Straight Connector 31"/>
          <p:cNvCxnSpPr/>
          <p:nvPr/>
        </p:nvCxnSpPr>
        <p:spPr>
          <a:xfrm>
            <a:off x="5220421" y="2007890"/>
            <a:ext cx="10016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426024" y="1998365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6382074" y="2007890"/>
            <a:ext cx="10016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7039372" y="2013223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605610" y="2013223"/>
            <a:ext cx="93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7561660" y="2013223"/>
            <a:ext cx="10016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8218958" y="2028081"/>
            <a:ext cx="8293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947769" y="1427635"/>
            <a:ext cx="18245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is-NlpI</a:t>
            </a:r>
          </a:p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LpoA 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7124280" y="1431827"/>
            <a:ext cx="18245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LpoA</a:t>
            </a:r>
          </a:p>
          <a:p>
            <a:pPr algn="ct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PBP4 </a:t>
            </a:r>
          </a:p>
        </p:txBody>
      </p:sp>
    </p:spTree>
    <p:extLst>
      <p:ext uri="{BB962C8B-B14F-4D97-AF65-F5344CB8AC3E}">
        <p14:creationId xmlns:p14="http://schemas.microsoft.com/office/powerpoint/2010/main" val="3104928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Widescreen</PresentationFormat>
  <Paragraphs>6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ish Yau</dc:creator>
  <cp:lastModifiedBy>Hamish Yau</cp:lastModifiedBy>
  <cp:revision>1</cp:revision>
  <dcterms:created xsi:type="dcterms:W3CDTF">2021-11-09T18:16:14Z</dcterms:created>
  <dcterms:modified xsi:type="dcterms:W3CDTF">2021-11-09T18:17:14Z</dcterms:modified>
</cp:coreProperties>
</file>